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>
        <p:scale>
          <a:sx n="172" d="100"/>
          <a:sy n="172" d="100"/>
        </p:scale>
        <p:origin x="1096" y="-29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3358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2377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562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7015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076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4708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7170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3729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4004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4475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1762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6DDA9-B897-4953-A508-5F3FA6AED41F}" type="datetimeFigureOut">
              <a:rPr lang="it-IT" smtClean="0"/>
              <a:t>14/09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7B440-5C75-4761-A959-9ADABEA6D66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5025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361BA3B8-D49B-454E-82BF-D2C8762407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307"/>
            <a:ext cx="6858000" cy="9705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1550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magine 8">
            <a:extLst>
              <a:ext uri="{FF2B5EF4-FFF2-40B4-BE49-F238E27FC236}">
                <a16:creationId xmlns:a16="http://schemas.microsoft.com/office/drawing/2014/main" id="{997FA722-E7DE-4AFE-BB61-417791FFF3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048"/>
            <a:ext cx="6858000" cy="4108704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C29BC197-A79F-4C6A-B75F-481C3C5768B4}"/>
              </a:ext>
            </a:extLst>
          </p:cNvPr>
          <p:cNvSpPr txBox="1"/>
          <p:nvPr/>
        </p:nvSpPr>
        <p:spPr>
          <a:xfrm>
            <a:off x="-1" y="4098205"/>
            <a:ext cx="6505575" cy="12926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9705" marR="179705" algn="just"/>
            <a:r>
              <a:rPr lang="it-IT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Figure S3. 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esign of the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neste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and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CAPS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markers targeting the </a:t>
            </a:r>
            <a:r>
              <a:rPr lang="it-IT" sz="11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Ve-1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gene. </a:t>
            </a:r>
            <a:r>
              <a:rPr lang="it-IT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)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ClustalW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lignment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between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the </a:t>
            </a:r>
            <a:r>
              <a:rPr lang="it-IT" sz="11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Ve-1 gene 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resistant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allele (FJ464557.1), </a:t>
            </a:r>
            <a:r>
              <a:rPr lang="it-IT" sz="11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Ve-1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susceptible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allele (FJ464555.1) and </a:t>
            </a:r>
            <a:r>
              <a:rPr lang="it-IT" sz="11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Ve-2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gene (AF365929.1). The red and blue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rrows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correspon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to the primer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pairs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for the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neste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PCR and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CAPS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marker,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respectively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. The red box </a:t>
            </a:r>
            <a:r>
              <a:rPr lang="it-IT" sz="1100" dirty="0" err="1">
                <a:solidFill>
                  <a:srgbClr val="000000"/>
                </a:solidFill>
                <a:latin typeface="Arial" panose="020B0604020202020204" pitchFamily="34" charset="0"/>
              </a:rPr>
              <a:t>evidence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the SNP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ssociate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with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susceptible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/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resistant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phenotype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. The position of the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mismatch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introduce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in the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forward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primer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is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lso</a:t>
            </a:r>
            <a:r>
              <a:rPr lang="it-IT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it-IT" sz="1100" dirty="0" err="1">
                <a:solidFill>
                  <a:srgbClr val="000000"/>
                </a:solidFill>
                <a:latin typeface="Arial" panose="020B0604020202020204" pitchFamily="34" charset="0"/>
              </a:rPr>
              <a:t>reported</a:t>
            </a:r>
            <a:r>
              <a:rPr lang="it-IT" sz="1100" dirty="0">
                <a:solidFill>
                  <a:srgbClr val="000000"/>
                </a:solidFill>
                <a:latin typeface="Arial" panose="020B0604020202020204" pitchFamily="34" charset="0"/>
              </a:rPr>
              <a:t> (in </a:t>
            </a:r>
            <a:r>
              <a:rPr lang="it-IT" sz="1100" dirty="0" err="1">
                <a:solidFill>
                  <a:srgbClr val="000000"/>
                </a:solidFill>
                <a:latin typeface="Arial" panose="020B0604020202020204" pitchFamily="34" charset="0"/>
              </a:rPr>
              <a:t>red</a:t>
            </a:r>
            <a:r>
              <a:rPr lang="it-IT" sz="1100" dirty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it-IT" sz="1100" dirty="0" err="1">
                <a:solidFill>
                  <a:srgbClr val="000000"/>
                </a:solidFill>
                <a:latin typeface="Arial" panose="020B0604020202020204" pitchFamily="34" charset="0"/>
              </a:rPr>
              <a:t>bold</a:t>
            </a:r>
            <a:r>
              <a:rPr lang="it-IT" sz="1100" dirty="0">
                <a:solidFill>
                  <a:srgbClr val="000000"/>
                </a:solidFill>
                <a:latin typeface="Arial" panose="020B0604020202020204" pitchFamily="34" charset="0"/>
              </a:rPr>
              <a:t>).</a:t>
            </a:r>
            <a:r>
              <a:rPr lang="it-IT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B)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Electrophoretic analysis of the </a:t>
            </a:r>
            <a:r>
              <a:rPr lang="en-US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CAPS</a:t>
            </a:r>
            <a:r>
              <a:rPr lang="en-US" sz="1100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marker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esigned for </a:t>
            </a:r>
            <a:r>
              <a:rPr lang="en-US" sz="11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Ve-1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gene on 4 hybrids and their parental lines.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10929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111</Words>
  <Application>Microsoft Macintosh PowerPoint</Application>
  <PresentationFormat>A4 (21x29,7 cm)</PresentationFormat>
  <Paragraphs>1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RIZIO OLIVIERI</dc:creator>
  <cp:lastModifiedBy>Amalia Barone</cp:lastModifiedBy>
  <cp:revision>4</cp:revision>
  <dcterms:created xsi:type="dcterms:W3CDTF">2021-09-09T09:35:11Z</dcterms:created>
  <dcterms:modified xsi:type="dcterms:W3CDTF">2021-09-14T09:04:52Z</dcterms:modified>
</cp:coreProperties>
</file>